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715"/>
    <p:restoredTop sz="93788"/>
  </p:normalViewPr>
  <p:slideViewPr>
    <p:cSldViewPr snapToGrid="0" snapToObjects="1">
      <p:cViewPr varScale="1">
        <p:scale>
          <a:sx n="102" d="100"/>
          <a:sy n="102" d="100"/>
        </p:scale>
        <p:origin x="56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ebeccapreyra/Pictures/TiME%20Tables%20and%20Figures/Extraction%20Spreadshee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7. Themes'!$R$28</c:f>
              <c:strCache>
                <c:ptCount val="1"/>
                <c:pt idx="0">
                  <c:v>Freq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fld id="{8CF5EE51-028C-DF4B-B4F0-EAB9701C1D6F}" type="CELLRANGE">
                      <a:rPr lang="en-US"/>
                      <a:pPr/>
                      <a:t>[CELLRANGE]</a:t>
                    </a:fld>
                    <a:r>
                      <a:rPr lang="en-US" baseline="0"/>
                      <a:t>, </a:t>
                    </a:r>
                    <a:fld id="{F80E2243-F2A3-944F-84A2-E1DC5E990AC1}" type="VALUE">
                      <a:rPr lang="en-US" baseline="0"/>
                      <a:pPr/>
                      <a:t>[VALUE]</a:t>
                    </a:fld>
                    <a:endParaRPr lang="en-US" baseline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0-E642-1B4A-A662-011756BC3438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fld id="{A251CA5B-91BE-5C4D-B7A0-78AE5E2BA101}" type="CELLRANGE">
                      <a:rPr lang="en-US"/>
                      <a:pPr/>
                      <a:t>[CELLRANGE]</a:t>
                    </a:fld>
                    <a:r>
                      <a:rPr lang="en-US" baseline="0"/>
                      <a:t>, </a:t>
                    </a:r>
                    <a:fld id="{9B3C5BE5-0CF8-9945-80DD-27FF135570F5}" type="VALUE">
                      <a:rPr lang="en-US" baseline="0"/>
                      <a:pPr/>
                      <a:t>[VALUE]</a:t>
                    </a:fld>
                    <a:endParaRPr lang="en-US" baseline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1-E642-1B4A-A662-011756BC3438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AB2C563E-6C42-4349-A4E0-C945E140BE2D}" type="CELLRANGE">
                      <a:rPr lang="en-US"/>
                      <a:pPr/>
                      <a:t>[CELLRANGE]</a:t>
                    </a:fld>
                    <a:r>
                      <a:rPr lang="en-US" baseline="0"/>
                      <a:t>, </a:t>
                    </a:r>
                    <a:fld id="{1ACBE2F4-291F-D245-BB72-55D5B4197B33}" type="VALUE">
                      <a:rPr lang="en-US" baseline="0"/>
                      <a:pPr/>
                      <a:t>[VALUE]</a:t>
                    </a:fld>
                    <a:endParaRPr lang="en-US" baseline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2-E642-1B4A-A662-011756BC3438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EE4BB2DB-6543-6245-AA72-5E3D6B9BE141}" type="CELLRANGE">
                      <a:rPr lang="en-US"/>
                      <a:pPr/>
                      <a:t>[CELLRANGE]</a:t>
                    </a:fld>
                    <a:r>
                      <a:rPr lang="en-US" baseline="0"/>
                      <a:t>, </a:t>
                    </a:r>
                    <a:fld id="{431B5058-1C74-154E-BDD2-CE411ADC1F82}" type="VALUE">
                      <a:rPr lang="en-US" baseline="0"/>
                      <a:pPr/>
                      <a:t>[VALUE]</a:t>
                    </a:fld>
                    <a:endParaRPr lang="en-US" baseline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3-E642-1B4A-A662-011756BC3438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B10BCAAC-ED1C-5D48-9D19-0060E88B95BD}" type="CELLRANGE">
                      <a:rPr lang="en-US"/>
                      <a:pPr/>
                      <a:t>[CELLRANGE]</a:t>
                    </a:fld>
                    <a:r>
                      <a:rPr lang="en-US" baseline="0"/>
                      <a:t>, </a:t>
                    </a:r>
                    <a:fld id="{88F2329A-73D3-704E-8A7B-4026A6932C3E}" type="VALUE">
                      <a:rPr lang="en-US" baseline="0"/>
                      <a:pPr/>
                      <a:t>[VALUE]</a:t>
                    </a:fld>
                    <a:endParaRPr lang="en-US" baseline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4-E642-1B4A-A662-011756BC3438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788DFDDA-2A5F-8849-9491-8A8564D71B69}" type="CELLRANGE">
                      <a:rPr lang="en-US"/>
                      <a:pPr/>
                      <a:t>[CELLRANGE]</a:t>
                    </a:fld>
                    <a:r>
                      <a:rPr lang="en-US" baseline="0"/>
                      <a:t>, </a:t>
                    </a:r>
                    <a:fld id="{37775F96-CEBB-D344-8FAE-9777BF51A4D8}" type="VALUE">
                      <a:rPr lang="en-US" baseline="0"/>
                      <a:pPr/>
                      <a:t>[VALUE]</a:t>
                    </a:fld>
                    <a:endParaRPr lang="en-US" baseline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5-E642-1B4A-A662-011756BC3438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fld id="{6E1EDF63-CC35-6444-B367-C7DADAB55510}" type="CELLRANGE">
                      <a:rPr lang="en-US"/>
                      <a:pPr/>
                      <a:t>[CELLRANGE]</a:t>
                    </a:fld>
                    <a:r>
                      <a:rPr lang="en-US" baseline="0"/>
                      <a:t>, </a:t>
                    </a:r>
                    <a:fld id="{832C49C3-25DB-9547-8BBF-63FA6EF64209}" type="VALUE">
                      <a:rPr lang="en-US" baseline="0"/>
                      <a:pPr/>
                      <a:t>[VALUE]</a:t>
                    </a:fld>
                    <a:endParaRPr lang="en-US" baseline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6-E642-1B4A-A662-011756BC3438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fld id="{F396BC8E-640F-EA43-A826-22E5340F2A00}" type="CELLRANGE">
                      <a:rPr lang="en-US"/>
                      <a:pPr/>
                      <a:t>[CELLRANGE]</a:t>
                    </a:fld>
                    <a:r>
                      <a:rPr lang="en-US" baseline="0"/>
                      <a:t>, </a:t>
                    </a:r>
                    <a:fld id="{7C6268F1-72A3-5F4F-A44C-15A03D380E2F}" type="VALUE">
                      <a:rPr lang="en-US" baseline="0"/>
                      <a:pPr/>
                      <a:t>[VALUE]</a:t>
                    </a:fld>
                    <a:endParaRPr lang="en-US" baseline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7-E642-1B4A-A662-011756BC3438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fld id="{FC1DF997-F023-8446-942A-64FBF7C6B7F6}" type="CELLRANGE">
                      <a:rPr lang="en-US"/>
                      <a:pPr/>
                      <a:t>[CELLRANGE]</a:t>
                    </a:fld>
                    <a:r>
                      <a:rPr lang="en-US" baseline="0"/>
                      <a:t>, </a:t>
                    </a:r>
                    <a:fld id="{F5AFD2BA-626E-E840-9F6F-A0CA36E4C18C}" type="VALUE">
                      <a:rPr lang="en-US" baseline="0"/>
                      <a:pPr/>
                      <a:t>[VALUE]</a:t>
                    </a:fld>
                    <a:endParaRPr lang="en-US" baseline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8-E642-1B4A-A662-011756BC3438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fld id="{30EC076B-B595-2C4E-8D81-D83270E04EF9}" type="CELLRANGE">
                      <a:rPr lang="en-US"/>
                      <a:pPr/>
                      <a:t>[CELLRANGE]</a:t>
                    </a:fld>
                    <a:r>
                      <a:rPr lang="en-US" baseline="0"/>
                      <a:t>, </a:t>
                    </a:r>
                    <a:fld id="{BDFA2BB3-6943-FD4A-AF6C-6A3F9827D73C}" type="VALUE">
                      <a:rPr lang="en-US" baseline="0"/>
                      <a:pPr/>
                      <a:t>[VALUE]</a:t>
                    </a:fld>
                    <a:endParaRPr lang="en-US" baseline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9-E642-1B4A-A662-011756BC3438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fld id="{254790A2-92CD-CB44-AFE0-75F83D1A2DB2}" type="CELLRANGE">
                      <a:rPr lang="en-US"/>
                      <a:pPr/>
                      <a:t>[CELLRANGE]</a:t>
                    </a:fld>
                    <a:r>
                      <a:rPr lang="en-US" baseline="0"/>
                      <a:t>, </a:t>
                    </a:r>
                    <a:fld id="{0D5BAF6F-C7E4-8244-A826-50F65261914C}" type="VALUE">
                      <a:rPr lang="en-US" baseline="0"/>
                      <a:pPr/>
                      <a:t>[VALUE]</a:t>
                    </a:fld>
                    <a:endParaRPr lang="en-US" baseline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A-E642-1B4A-A662-011756BC343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rgbClr val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7. Themes'!$Q$29:$Q$39</c:f>
              <c:strCache>
                <c:ptCount val="11"/>
                <c:pt idx="0">
                  <c:v>Multi-talented individuals</c:v>
                </c:pt>
                <c:pt idx="1">
                  <c:v>Emotional intellegence</c:v>
                </c:pt>
                <c:pt idx="2">
                  <c:v>Defining talent</c:v>
                </c:pt>
                <c:pt idx="3">
                  <c:v>Equity, diversity, and Inclusion</c:v>
                </c:pt>
                <c:pt idx="4">
                  <c:v>Emerging new leaders</c:v>
                </c:pt>
                <c:pt idx="5">
                  <c:v>Culture of the institution around talent</c:v>
                </c:pt>
                <c:pt idx="6">
                  <c:v>Talent management</c:v>
                </c:pt>
                <c:pt idx="7">
                  <c:v>Retention</c:v>
                </c:pt>
                <c:pt idx="8">
                  <c:v>Recruitment</c:v>
                </c:pt>
                <c:pt idx="9">
                  <c:v>Talent development</c:v>
                </c:pt>
                <c:pt idx="10">
                  <c:v>Identifying talent</c:v>
                </c:pt>
              </c:strCache>
            </c:strRef>
          </c:cat>
          <c:val>
            <c:numRef>
              <c:f>'7. Themes'!$R$29:$R$39</c:f>
              <c:numCache>
                <c:formatCode>General</c:formatCode>
                <c:ptCount val="11"/>
                <c:pt idx="0">
                  <c:v>1</c:v>
                </c:pt>
                <c:pt idx="1">
                  <c:v>1</c:v>
                </c:pt>
                <c:pt idx="2">
                  <c:v>3</c:v>
                </c:pt>
                <c:pt idx="3">
                  <c:v>3</c:v>
                </c:pt>
                <c:pt idx="4">
                  <c:v>7</c:v>
                </c:pt>
                <c:pt idx="5">
                  <c:v>13</c:v>
                </c:pt>
                <c:pt idx="6">
                  <c:v>15</c:v>
                </c:pt>
                <c:pt idx="7">
                  <c:v>16</c:v>
                </c:pt>
                <c:pt idx="8">
                  <c:v>29</c:v>
                </c:pt>
                <c:pt idx="9">
                  <c:v>43</c:v>
                </c:pt>
                <c:pt idx="10">
                  <c:v>136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'7. Themes'!$T$29:$T$39</c15:f>
                <c15:dlblRangeCache>
                  <c:ptCount val="11"/>
                  <c:pt idx="0">
                    <c:v>0%</c:v>
                  </c:pt>
                  <c:pt idx="1">
                    <c:v>0%</c:v>
                  </c:pt>
                  <c:pt idx="2">
                    <c:v>1%</c:v>
                  </c:pt>
                  <c:pt idx="3">
                    <c:v>1%</c:v>
                  </c:pt>
                  <c:pt idx="4">
                    <c:v>3%</c:v>
                  </c:pt>
                  <c:pt idx="5">
                    <c:v>5%</c:v>
                  </c:pt>
                  <c:pt idx="6">
                    <c:v>6%</c:v>
                  </c:pt>
                  <c:pt idx="7">
                    <c:v>6%</c:v>
                  </c:pt>
                  <c:pt idx="8">
                    <c:v>11%</c:v>
                  </c:pt>
                  <c:pt idx="9">
                    <c:v>16%</c:v>
                  </c:pt>
                  <c:pt idx="10">
                    <c:v>51%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B-E642-1B4A-A662-011756BC3438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82"/>
        <c:axId val="1734057808"/>
        <c:axId val="1734056848"/>
      </c:barChart>
      <c:catAx>
        <c:axId val="173405780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34056848"/>
        <c:crosses val="autoZero"/>
        <c:auto val="1"/>
        <c:lblAlgn val="ctr"/>
        <c:lblOffset val="100"/>
        <c:noMultiLvlLbl val="0"/>
      </c:catAx>
      <c:valAx>
        <c:axId val="173405684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200" b="0">
                    <a:solidFill>
                      <a:sysClr val="windowText" lastClr="000000"/>
                    </a:solidFill>
                  </a:rPr>
                  <a:t>No. of publication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340578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73B533-89B7-2F4C-B477-4860FCD7A212}" type="datetimeFigureOut">
              <a:rPr lang="en-US" smtClean="0"/>
              <a:t>4/12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3E6613-341F-2C43-8796-9C3C879B90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07755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E3A5DC-69FB-2747-B394-67E4015EBA5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9C87EA6-CBC8-4D43-A2DF-C5A1A1AD9F3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FE0A64-153C-3842-A77D-6A195423F0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BFC9B-1AE8-4646-A3BD-28FD3D53DA86}" type="datetimeFigureOut">
              <a:rPr lang="en-US" smtClean="0"/>
              <a:t>4/1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A0646F-8BAD-8546-8273-AA15EDA980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699959-E86E-8949-A8F4-074153C2AF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D3CA5-F2E1-4146-9B4A-D82EC53EB6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0420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D5F858-72D2-A940-96F7-D2726CC5DE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E49088E-EF5C-2043-A01B-09DDF6C6AF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5D63CD-D83B-0C42-BE0E-E62978632C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BFC9B-1AE8-4646-A3BD-28FD3D53DA86}" type="datetimeFigureOut">
              <a:rPr lang="en-US" smtClean="0"/>
              <a:t>4/1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D2D05C-54A3-2B4D-B8C4-44A4A3B8F5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224200-1200-6E4E-BA55-6BA859792D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D3CA5-F2E1-4146-9B4A-D82EC53EB6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76766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D72A6FC-F28D-5A4D-AD0B-FE6547E81E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CD4C0C1-8876-294C-BA0F-538190F6B4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1ABBE4-BEB4-E340-B18C-35FC89DF2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BFC9B-1AE8-4646-A3BD-28FD3D53DA86}" type="datetimeFigureOut">
              <a:rPr lang="en-US" smtClean="0"/>
              <a:t>4/1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FF9A6A-6802-6B48-9C20-F094987033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8E5919-8611-9944-A81C-827C6593C8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D3CA5-F2E1-4146-9B4A-D82EC53EB6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72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BEBCFB-51E9-A44E-8672-9D0A6BB7A4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499E27-7EEF-E547-A8A8-8F9BB8554A3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2D6F75-F335-A84D-9A47-4FB2B74C2B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BFC9B-1AE8-4646-A3BD-28FD3D53DA86}" type="datetimeFigureOut">
              <a:rPr lang="en-US" smtClean="0"/>
              <a:t>4/1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90DABE-AA9A-D246-8E4A-3652B517A0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01BA1B-3FFF-E24E-999C-E2030277A1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D3CA5-F2E1-4146-9B4A-D82EC53EB6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302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FD9025-B67E-2740-A20D-462A68F581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17B15B-B496-AE4E-9A29-51339FC959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1AF5D9-D592-3E47-AD07-57489F4878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BFC9B-1AE8-4646-A3BD-28FD3D53DA86}" type="datetimeFigureOut">
              <a:rPr lang="en-US" smtClean="0"/>
              <a:t>4/1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0234F1-EDE6-D244-9059-75863041DB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9AE4B1-D395-8A4E-9AD9-0650058DD8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D3CA5-F2E1-4146-9B4A-D82EC53EB6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5242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81255A-5C78-0D49-9D75-C562B5DCB0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40FD2D-6CB8-FE41-811A-428BDF0006D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5DA64ED-C236-844C-9B2C-CB8B99C2EA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7762AA-F488-E94B-BD3F-DCCB568319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BFC9B-1AE8-4646-A3BD-28FD3D53DA86}" type="datetimeFigureOut">
              <a:rPr lang="en-US" smtClean="0"/>
              <a:t>4/1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528A97-3453-914E-8932-84DA16C4D2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1309F1-D109-2C43-B34D-DCFCA43906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D3CA5-F2E1-4146-9B4A-D82EC53EB6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9216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7A0CF0-6040-1A47-94FF-B6F818F5AF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179176-D3E1-D844-8A93-040EAE446C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F24806-C98A-454D-AF40-3F2EFAB550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DF959BF-6521-8E47-AC72-EFA1846B22A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A89BBA9-75FB-304A-89F4-84FEB6BF64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F83B890-490F-FD44-9C09-3F7CC6BF2F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BFC9B-1AE8-4646-A3BD-28FD3D53DA86}" type="datetimeFigureOut">
              <a:rPr lang="en-US" smtClean="0"/>
              <a:t>4/12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772887D-6A68-B644-9038-FE846352FB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9D8CDB1-DE2F-6C44-9839-3B53B6F24D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D3CA5-F2E1-4146-9B4A-D82EC53EB6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69014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FEB00A-1012-BC47-AE75-DCDD33B67E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4F56C64-E75E-8249-B419-0A26F17720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BFC9B-1AE8-4646-A3BD-28FD3D53DA86}" type="datetimeFigureOut">
              <a:rPr lang="en-US" smtClean="0"/>
              <a:t>4/12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9429C70-EA06-8B47-8A80-FB176B6274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D04D390-1F7C-BB47-931B-CF64775F7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D3CA5-F2E1-4146-9B4A-D82EC53EB6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2562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A1865F0-C597-7D4A-9971-1198809C88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BFC9B-1AE8-4646-A3BD-28FD3D53DA86}" type="datetimeFigureOut">
              <a:rPr lang="en-US" smtClean="0"/>
              <a:t>4/12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5E352BA-240D-A74C-B461-1F0A604489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B199E02-2301-B542-84D4-8B574592F9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D3CA5-F2E1-4146-9B4A-D82EC53EB6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0652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66F1C4-8249-0343-ACA6-51D49ECF7D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3AA45B-F5CD-224D-90E4-5752207A3F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57ACA50-A15F-954E-8E83-5EDF9916CA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802E4D-C7FC-BD4B-9914-7B16CE6232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BFC9B-1AE8-4646-A3BD-28FD3D53DA86}" type="datetimeFigureOut">
              <a:rPr lang="en-US" smtClean="0"/>
              <a:t>4/1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2DAF7C-388D-3F4D-B12E-4797790A7D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D9E4D0-80F9-2B4B-A799-C92E97E398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D3CA5-F2E1-4146-9B4A-D82EC53EB6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2541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F70F23-5F1A-1645-97BF-086726768A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0F4ED0C-82B6-3E44-90BE-FD1F1F27798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5BE3E16-6E50-5148-A29A-AB63F0307D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6442DD-8298-1847-9BE7-F85EA3E4F7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BFC9B-1AE8-4646-A3BD-28FD3D53DA86}" type="datetimeFigureOut">
              <a:rPr lang="en-US" smtClean="0"/>
              <a:t>4/1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E85130-3E6F-5040-B9E0-4EEADC44FE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471B36-89D7-1144-9A9D-1D7F5C4AD2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D3CA5-F2E1-4146-9B4A-D82EC53EB6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31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1AA626A-F8FD-0A44-ACC2-0BEE207656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30E82A-3F09-2842-86BD-502818D6AD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1B7BD7-E581-F84C-B594-1CE77EC552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8BFC9B-1AE8-4646-A3BD-28FD3D53DA86}" type="datetimeFigureOut">
              <a:rPr lang="en-US" smtClean="0"/>
              <a:t>4/1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655F53-E792-284F-A2C7-764403E9999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B1FC9B-403C-394B-8D65-13527F63C04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0D3CA5-F2E1-4146-9B4A-D82EC53EB6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78690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CAB71AFE-756B-A069-AB27-DDA48535290A}"/>
              </a:ext>
            </a:extLst>
          </p:cNvPr>
          <p:cNvGraphicFramePr>
            <a:graphicFrameLocks/>
          </p:cNvGraphicFramePr>
          <p:nvPr/>
        </p:nvGraphicFramePr>
        <p:xfrm>
          <a:off x="2574748" y="1368425"/>
          <a:ext cx="7042503" cy="41211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069FC9F9-D43F-5546-C6B2-6BEC11EB9544}"/>
              </a:ext>
            </a:extLst>
          </p:cNvPr>
          <p:cNvSpPr txBox="1"/>
          <p:nvPr/>
        </p:nvSpPr>
        <p:spPr>
          <a:xfrm>
            <a:off x="926925" y="162838"/>
            <a:ext cx="9222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ppendix F: Themes from the medical education literature about Talent or Talent adjacent terms</a:t>
            </a:r>
          </a:p>
        </p:txBody>
      </p:sp>
    </p:spTree>
    <p:extLst>
      <p:ext uri="{BB962C8B-B14F-4D97-AF65-F5344CB8AC3E}">
        <p14:creationId xmlns:p14="http://schemas.microsoft.com/office/powerpoint/2010/main" val="550889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0</TotalTime>
  <Words>19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becca Preyra</dc:creator>
  <cp:lastModifiedBy>Chan, Teresa</cp:lastModifiedBy>
  <cp:revision>10</cp:revision>
  <dcterms:created xsi:type="dcterms:W3CDTF">2025-03-26T21:43:31Z</dcterms:created>
  <dcterms:modified xsi:type="dcterms:W3CDTF">2025-04-12T18:25:26Z</dcterms:modified>
</cp:coreProperties>
</file>